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69"/>
    <p:restoredTop sz="95728"/>
  </p:normalViewPr>
  <p:slideViewPr>
    <p:cSldViewPr snapToGrid="0" snapToObjects="1">
      <p:cViewPr varScale="1">
        <p:scale>
          <a:sx n="106" d="100"/>
          <a:sy n="106" d="100"/>
        </p:scale>
        <p:origin x="19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79A24243-3E89-3144-B784-413024C828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4675" y="4026088"/>
            <a:ext cx="2457453" cy="2457453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109159A7-E599-D743-BE79-ED18CE68C6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444" y="4026088"/>
            <a:ext cx="2467090" cy="2457453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7C5BA2D1-72D3-4B4C-96FE-545A4AD6A2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04675" y="1429163"/>
            <a:ext cx="2455813" cy="2455813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219DDB2C-7EAE-8E4D-8955-454F5ABF53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3443" y="1429163"/>
            <a:ext cx="2470992" cy="245168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C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s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FLAG-Gpr101 and Pit-1 in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t least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A091BE7-7575-6E4E-A30D-B5E989C1ABA3}"/>
              </a:ext>
            </a:extLst>
          </p:cNvPr>
          <p:cNvSpPr/>
          <p:nvPr/>
        </p:nvSpPr>
        <p:spPr>
          <a:xfrm>
            <a:off x="5751446" y="4899473"/>
            <a:ext cx="6096000" cy="132343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</a:t>
            </a:r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nterior pituitary)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goat anti-GH (R&amp;D systems, Cat. No AF1067-SP, dilution 1:133) antibody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anti-</a:t>
            </a: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Cat. No ab150129, dilution 1:200) </a:t>
            </a: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751446" y="1550369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751446" y="2748816"/>
            <a:ext cx="6096000" cy="132343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-IgG-</a:t>
            </a:r>
            <a:r>
              <a:rPr lang="en-US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to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47N conjugate (Sigma-Aldrich, Cat. No 50185, dilution 1:200) 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200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2</cp:revision>
  <dcterms:created xsi:type="dcterms:W3CDTF">2020-05-09T12:35:08Z</dcterms:created>
  <dcterms:modified xsi:type="dcterms:W3CDTF">2020-05-25T16:54:16Z</dcterms:modified>
</cp:coreProperties>
</file>